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0267275" cy="427942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79" userDrawn="1">
          <p15:clr>
            <a:srgbClr val="A4A3A4"/>
          </p15:clr>
        </p15:guide>
        <p15:guide id="2" pos="95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>
        <p:scale>
          <a:sx n="30" d="100"/>
          <a:sy n="30" d="100"/>
        </p:scale>
        <p:origin x="474" y="-4812"/>
      </p:cViewPr>
      <p:guideLst>
        <p:guide orient="horz" pos="13479"/>
        <p:guide pos="95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046" y="7003597"/>
            <a:ext cx="25727184" cy="14898735"/>
          </a:xfrm>
        </p:spPr>
        <p:txBody>
          <a:bodyPr anchor="b"/>
          <a:lstStyle>
            <a:lvl1pPr algn="ctr"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3410" y="22476884"/>
            <a:ext cx="22700456" cy="10332032"/>
          </a:xfrm>
        </p:spPr>
        <p:txBody>
          <a:bodyPr/>
          <a:lstStyle>
            <a:lvl1pPr marL="0" indent="0" algn="ctr">
              <a:buNone/>
              <a:defRPr sz="7944"/>
            </a:lvl1pPr>
            <a:lvl2pPr marL="1513378" indent="0" algn="ctr">
              <a:buNone/>
              <a:defRPr sz="6620"/>
            </a:lvl2pPr>
            <a:lvl3pPr marL="3026755" indent="0" algn="ctr">
              <a:buNone/>
              <a:defRPr sz="5958"/>
            </a:lvl3pPr>
            <a:lvl4pPr marL="4540133" indent="0" algn="ctr">
              <a:buNone/>
              <a:defRPr sz="5296"/>
            </a:lvl4pPr>
            <a:lvl5pPr marL="6053511" indent="0" algn="ctr">
              <a:buNone/>
              <a:defRPr sz="5296"/>
            </a:lvl5pPr>
            <a:lvl6pPr marL="7566889" indent="0" algn="ctr">
              <a:buNone/>
              <a:defRPr sz="5296"/>
            </a:lvl6pPr>
            <a:lvl7pPr marL="9080266" indent="0" algn="ctr">
              <a:buNone/>
              <a:defRPr sz="5296"/>
            </a:lvl7pPr>
            <a:lvl8pPr marL="10593644" indent="0" algn="ctr">
              <a:buNone/>
              <a:defRPr sz="5296"/>
            </a:lvl8pPr>
            <a:lvl9pPr marL="12107022" indent="0" algn="ctr">
              <a:buNone/>
              <a:defRPr sz="52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15183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29723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0020" y="2278397"/>
            <a:ext cx="6526381" cy="362661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0877" y="2278397"/>
            <a:ext cx="19200803" cy="362661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05281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1472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112" y="10668854"/>
            <a:ext cx="26105525" cy="17801211"/>
          </a:xfrm>
        </p:spPr>
        <p:txBody>
          <a:bodyPr anchor="b"/>
          <a:lstStyle>
            <a:lvl1pPr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112" y="28638472"/>
            <a:ext cx="26105525" cy="9361236"/>
          </a:xfrm>
        </p:spPr>
        <p:txBody>
          <a:bodyPr/>
          <a:lstStyle>
            <a:lvl1pPr marL="0" indent="0">
              <a:buNone/>
              <a:defRPr sz="7944">
                <a:solidFill>
                  <a:schemeClr val="tx1"/>
                </a:solidFill>
              </a:defRPr>
            </a:lvl1pPr>
            <a:lvl2pPr marL="1513378" indent="0">
              <a:buNone/>
              <a:defRPr sz="6620">
                <a:solidFill>
                  <a:schemeClr val="tx1">
                    <a:tint val="75000"/>
                  </a:schemeClr>
                </a:solidFill>
              </a:defRPr>
            </a:lvl2pPr>
            <a:lvl3pPr marL="3026755" indent="0">
              <a:buNone/>
              <a:defRPr sz="5958">
                <a:solidFill>
                  <a:schemeClr val="tx1">
                    <a:tint val="75000"/>
                  </a:schemeClr>
                </a:solidFill>
              </a:defRPr>
            </a:lvl3pPr>
            <a:lvl4pPr marL="4540133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4pPr>
            <a:lvl5pPr marL="6053511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5pPr>
            <a:lvl6pPr marL="7566889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6pPr>
            <a:lvl7pPr marL="9080266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7pPr>
            <a:lvl8pPr marL="10593644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8pPr>
            <a:lvl9pPr marL="12107022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01135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0875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2808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66185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278406"/>
            <a:ext cx="26105525" cy="82715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4821" y="10490535"/>
            <a:ext cx="1280447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4821" y="15631784"/>
            <a:ext cx="1280447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2810" y="10490535"/>
            <a:ext cx="1286753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2810" y="15631784"/>
            <a:ext cx="1286753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54593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24168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60699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67534" y="6161587"/>
            <a:ext cx="15322808" cy="30411646"/>
          </a:xfrm>
        </p:spPr>
        <p:txBody>
          <a:bodyPr/>
          <a:lstStyle>
            <a:lvl1pPr>
              <a:defRPr sz="10592"/>
            </a:lvl1pPr>
            <a:lvl2pPr>
              <a:defRPr sz="9268"/>
            </a:lvl2pPr>
            <a:lvl3pPr>
              <a:defRPr sz="7944"/>
            </a:lvl3pPr>
            <a:lvl4pPr>
              <a:defRPr sz="6620"/>
            </a:lvl4pPr>
            <a:lvl5pPr>
              <a:defRPr sz="6620"/>
            </a:lvl5pPr>
            <a:lvl6pPr>
              <a:defRPr sz="6620"/>
            </a:lvl6pPr>
            <a:lvl7pPr>
              <a:defRPr sz="6620"/>
            </a:lvl7pPr>
            <a:lvl8pPr>
              <a:defRPr sz="6620"/>
            </a:lvl8pPr>
            <a:lvl9pPr>
              <a:defRPr sz="6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63851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67534" y="6161587"/>
            <a:ext cx="15322808" cy="30411646"/>
          </a:xfrm>
        </p:spPr>
        <p:txBody>
          <a:bodyPr anchor="t"/>
          <a:lstStyle>
            <a:lvl1pPr marL="0" indent="0">
              <a:buNone/>
              <a:defRPr sz="10592"/>
            </a:lvl1pPr>
            <a:lvl2pPr marL="1513378" indent="0">
              <a:buNone/>
              <a:defRPr sz="9268"/>
            </a:lvl2pPr>
            <a:lvl3pPr marL="3026755" indent="0">
              <a:buNone/>
              <a:defRPr sz="7944"/>
            </a:lvl3pPr>
            <a:lvl4pPr marL="4540133" indent="0">
              <a:buNone/>
              <a:defRPr sz="6620"/>
            </a:lvl4pPr>
            <a:lvl5pPr marL="6053511" indent="0">
              <a:buNone/>
              <a:defRPr sz="6620"/>
            </a:lvl5pPr>
            <a:lvl6pPr marL="7566889" indent="0">
              <a:buNone/>
              <a:defRPr sz="6620"/>
            </a:lvl6pPr>
            <a:lvl7pPr marL="9080266" indent="0">
              <a:buNone/>
              <a:defRPr sz="6620"/>
            </a:lvl7pPr>
            <a:lvl8pPr marL="10593644" indent="0">
              <a:buNone/>
              <a:defRPr sz="6620"/>
            </a:lvl8pPr>
            <a:lvl9pPr marL="12107022" indent="0">
              <a:buNone/>
              <a:defRPr sz="66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5158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0875" y="2278406"/>
            <a:ext cx="26105525" cy="8271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0875" y="11391985"/>
            <a:ext cx="26105525" cy="271525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0875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A85EC-188E-4B19-9270-F7A3DC17DBD2}" type="datetimeFigureOut">
              <a:rPr lang="en-ZA" smtClean="0"/>
              <a:t>2019/12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26035" y="39663928"/>
            <a:ext cx="10215205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76263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8843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6755" rtl="0" eaLnBrk="1" latinLnBrk="0" hangingPunct="1">
        <a:lnSpc>
          <a:spcPct val="90000"/>
        </a:lnSpc>
        <a:spcBef>
          <a:spcPct val="0"/>
        </a:spcBef>
        <a:buNone/>
        <a:defRPr sz="145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6689" indent="-756689" algn="l" defTabSz="3026755" rtl="0" eaLnBrk="1" latinLnBrk="0" hangingPunct="1">
        <a:lnSpc>
          <a:spcPct val="90000"/>
        </a:lnSpc>
        <a:spcBef>
          <a:spcPts val="3310"/>
        </a:spcBef>
        <a:buFont typeface="Arial" panose="020B0604020202020204" pitchFamily="34" charset="0"/>
        <a:buChar char="•"/>
        <a:defRPr sz="9268" kern="1200">
          <a:solidFill>
            <a:schemeClr val="tx1"/>
          </a:solidFill>
          <a:latin typeface="+mn-lt"/>
          <a:ea typeface="+mn-ea"/>
          <a:cs typeface="+mn-cs"/>
        </a:defRPr>
      </a:lvl1pPr>
      <a:lvl2pPr marL="227006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7944" kern="1200">
          <a:solidFill>
            <a:schemeClr val="tx1"/>
          </a:solidFill>
          <a:latin typeface="+mn-lt"/>
          <a:ea typeface="+mn-ea"/>
          <a:cs typeface="+mn-cs"/>
        </a:defRPr>
      </a:lvl2pPr>
      <a:lvl3pPr marL="3783444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6620" kern="1200">
          <a:solidFill>
            <a:schemeClr val="tx1"/>
          </a:solidFill>
          <a:latin typeface="+mn-lt"/>
          <a:ea typeface="+mn-ea"/>
          <a:cs typeface="+mn-cs"/>
        </a:defRPr>
      </a:lvl3pPr>
      <a:lvl4pPr marL="5296822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810200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832357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836955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1350333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863711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1pPr>
      <a:lvl2pPr marL="1513378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2pPr>
      <a:lvl3pPr marL="3026755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3pPr>
      <a:lvl4pPr marL="4540133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053511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7566889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080266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0593644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107022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B1B3F33-B370-4B84-ADFD-DAA080D97C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2063" y="7535442"/>
            <a:ext cx="19676605" cy="409837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70B3387-7969-4ADD-834A-F773534112EB}"/>
              </a:ext>
            </a:extLst>
          </p:cNvPr>
          <p:cNvSpPr txBox="1"/>
          <p:nvPr/>
        </p:nvSpPr>
        <p:spPr>
          <a:xfrm>
            <a:off x="14359693" y="5937052"/>
            <a:ext cx="52931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3055669-B9CA-460F-B04B-D6B5BC047F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4635" y="1525218"/>
            <a:ext cx="21139644" cy="388369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20F9C1B-D448-4240-B9BC-FA64446F8CF3}"/>
              </a:ext>
            </a:extLst>
          </p:cNvPr>
          <p:cNvSpPr txBox="1"/>
          <p:nvPr/>
        </p:nvSpPr>
        <p:spPr>
          <a:xfrm>
            <a:off x="14359693" y="126355"/>
            <a:ext cx="55816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36459E1-17D5-422D-9F39-EC0644B10B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9343" y="13486832"/>
            <a:ext cx="12597368" cy="356721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8C629A4-4DB3-460B-88EA-F71608EB1C34}"/>
              </a:ext>
            </a:extLst>
          </p:cNvPr>
          <p:cNvSpPr txBox="1"/>
          <p:nvPr/>
        </p:nvSpPr>
        <p:spPr>
          <a:xfrm>
            <a:off x="7138027" y="12154863"/>
            <a:ext cx="51007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9A4F761-575D-4EBC-8BCF-C7A4B115B5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060366" y="13168602"/>
            <a:ext cx="15209011" cy="398704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4FE84B6-C28D-43BC-9B99-F71FDB228CE3}"/>
              </a:ext>
            </a:extLst>
          </p:cNvPr>
          <p:cNvSpPr txBox="1"/>
          <p:nvPr/>
        </p:nvSpPr>
        <p:spPr>
          <a:xfrm>
            <a:off x="21871224" y="12154863"/>
            <a:ext cx="57259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D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D2FA4B63-57DD-4F01-B73E-1558B216BD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13663" y="20034049"/>
            <a:ext cx="12358770" cy="249630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EDE7F7C-D489-43E7-8C57-F028532691DC}"/>
              </a:ext>
            </a:extLst>
          </p:cNvPr>
          <p:cNvSpPr txBox="1"/>
          <p:nvPr/>
        </p:nvSpPr>
        <p:spPr>
          <a:xfrm>
            <a:off x="8876017" y="18361977"/>
            <a:ext cx="48442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E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C693469-9AD4-4142-B881-88C7A6978E9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979965" y="19550379"/>
            <a:ext cx="15209011" cy="304532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2FF1709-1210-464C-890A-27EA92D7ECD9}"/>
              </a:ext>
            </a:extLst>
          </p:cNvPr>
          <p:cNvSpPr txBox="1"/>
          <p:nvPr/>
        </p:nvSpPr>
        <p:spPr>
          <a:xfrm>
            <a:off x="21871224" y="18361977"/>
            <a:ext cx="46679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F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EEBC4CDA-A0AF-4198-926D-7E431EFC021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61076" y="31578067"/>
            <a:ext cx="21837777" cy="462387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E6C26EB-F4A4-4A3C-961E-97A9B54D2A17}"/>
              </a:ext>
            </a:extLst>
          </p:cNvPr>
          <p:cNvSpPr txBox="1"/>
          <p:nvPr/>
        </p:nvSpPr>
        <p:spPr>
          <a:xfrm>
            <a:off x="14266718" y="30334887"/>
            <a:ext cx="57259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C78D739-A3DC-44C8-8A18-2EE7084B3E21}"/>
              </a:ext>
            </a:extLst>
          </p:cNvPr>
          <p:cNvSpPr txBox="1"/>
          <p:nvPr/>
        </p:nvSpPr>
        <p:spPr>
          <a:xfrm>
            <a:off x="700051" y="36687716"/>
            <a:ext cx="29567224" cy="52491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1. Schematic illustration of RNA-seq data aligned to that of the genes identified in </a:t>
            </a:r>
            <a:r>
              <a:rPr lang="en-US" sz="3600" b="1" i="1" dirty="0">
                <a:latin typeface="Palatino Linotype" panose="02040502050505030304" pitchFamily="18" charset="0"/>
                <a:cs typeface="Arial" panose="020B0604020202020204" pitchFamily="34" charset="0"/>
              </a:rPr>
              <a:t>Neurospora </a:t>
            </a:r>
            <a:r>
              <a:rPr lang="en-US" sz="3600" b="1" i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crassa</a:t>
            </a:r>
            <a:r>
              <a:rPr lang="en-US" sz="3600" b="1" i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associated with RIP, to that of </a:t>
            </a:r>
            <a:r>
              <a:rPr lang="en-US" sz="3600" b="1" i="1" dirty="0">
                <a:latin typeface="Palatino Linotype" panose="02040502050505030304" pitchFamily="18" charset="0"/>
                <a:cs typeface="Arial" panose="020B0604020202020204" pitchFamily="34" charset="0"/>
              </a:rPr>
              <a:t>Fusarium circinatum </a:t>
            </a: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putative homologous sequences (Table S1). </a:t>
            </a: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The figures (A-H) depicts aligned RNA Seq data for HP-1, Dim-2, Rid-1, Dim-5, Dim-3, Dim-7, Dim-8, and Dim-9, respectively</a:t>
            </a: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  <a:r>
              <a:rPr lang="en-US" sz="36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1</a:t>
            </a: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sz="3200" baseline="30000">
                <a:latin typeface="Palatino Linotype" panose="02040502050505030304" pitchFamily="18" charset="0"/>
                <a:cs typeface="Arial" panose="020B0604020202020204" pitchFamily="34" charset="0"/>
              </a:rPr>
              <a:t>1</a:t>
            </a:r>
            <a:r>
              <a:rPr lang="en-US" sz="3200">
                <a:latin typeface="Palatino Linotype" panose="02040502050505030304" pitchFamily="18" charset="0"/>
                <a:cs typeface="Arial" panose="020B0604020202020204" pitchFamily="34" charset="0"/>
              </a:rPr>
              <a:t>RNA-seq </a:t>
            </a:r>
            <a:r>
              <a:rPr lang="en-ZA" sz="3200">
                <a:latin typeface="Palatino Linotype" panose="02040502050505030304" pitchFamily="18" charset="0"/>
                <a:cs typeface="Arial" panose="020B0604020202020204" pitchFamily="34" charset="0"/>
              </a:rPr>
              <a:t>unpublished </a:t>
            </a:r>
            <a:r>
              <a:rPr lang="en-ZA" sz="3200" dirty="0">
                <a:latin typeface="Palatino Linotype" panose="02040502050505030304" pitchFamily="18" charset="0"/>
                <a:cs typeface="Arial" panose="020B0604020202020204" pitchFamily="34" charset="0"/>
              </a:rPr>
              <a:t>data, personal communications with Ms. M. </a:t>
            </a:r>
            <a:r>
              <a:rPr lang="en-ZA" sz="32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hasha</a:t>
            </a:r>
            <a:r>
              <a:rPr lang="en-ZA" sz="3200" dirty="0">
                <a:latin typeface="Palatino Linotype" panose="02040502050505030304" pitchFamily="18" charset="0"/>
                <a:cs typeface="Arial" panose="020B0604020202020204" pitchFamily="34" charset="0"/>
              </a:rPr>
              <a:t>, Forestry and Agricultural biotechnology Institute, (FABI), University of Pretoria; Table S1. </a:t>
            </a:r>
            <a:endParaRPr lang="en-ZA" sz="3200" dirty="0">
              <a:latin typeface="Palatino Linotype" panose="0204050205050503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0B927A3-37CD-4D0F-B08D-170E40AEF4A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455859" y="24940979"/>
            <a:ext cx="15209011" cy="4446085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4EA2A729-E316-4273-8D49-03478D82716B}"/>
              </a:ext>
            </a:extLst>
          </p:cNvPr>
          <p:cNvSpPr txBox="1"/>
          <p:nvPr/>
        </p:nvSpPr>
        <p:spPr>
          <a:xfrm>
            <a:off x="14266718" y="23488392"/>
            <a:ext cx="5774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4800" b="1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1483584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2</TotalTime>
  <Words>102</Words>
  <Application>Microsoft Office PowerPoint</Application>
  <PresentationFormat>Custom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van Wyk</dc:creator>
  <cp:lastModifiedBy>Ms. S van Wyk</cp:lastModifiedBy>
  <cp:revision>16</cp:revision>
  <dcterms:created xsi:type="dcterms:W3CDTF">2019-08-08T15:46:07Z</dcterms:created>
  <dcterms:modified xsi:type="dcterms:W3CDTF">2019-12-04T16:14:43Z</dcterms:modified>
</cp:coreProperties>
</file>